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264" r:id="rId5"/>
    <p:sldId id="278" r:id="rId6"/>
    <p:sldId id="272" r:id="rId7"/>
    <p:sldId id="279" r:id="rId8"/>
    <p:sldId id="275" r:id="rId9"/>
    <p:sldId id="280" r:id="rId10"/>
  </p:sldIdLst>
  <p:sldSz cx="7772400" cy="10058400"/>
  <p:notesSz cx="6858000" cy="9144000"/>
  <p:defaultTextStyle>
    <a:defPPr>
      <a:defRPr lang="en-US"/>
    </a:defPPr>
    <a:lvl1pPr marL="0" algn="l" defTabSz="9142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46" algn="l" defTabSz="9142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94" algn="l" defTabSz="9142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40" algn="l" defTabSz="9142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86" algn="l" defTabSz="9142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32" algn="l" defTabSz="9142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80" algn="l" defTabSz="9142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26" algn="l" defTabSz="9142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172" algn="l" defTabSz="91429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64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4910">
          <p15:clr>
            <a:srgbClr val="A4A3A4"/>
          </p15:clr>
        </p15:guide>
        <p15:guide id="4" pos="2448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emenoff, Raphael" initials="NR" lastIdx="2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99"/>
    <a:srgbClr val="FFCCFF"/>
    <a:srgbClr val="FF99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C001A35-64E2-4C02-B088-2500CCE34249}" v="2" dt="2019-03-05T18:11:13.47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1639" autoAdjust="0"/>
    <p:restoredTop sz="99145" autoAdjust="0"/>
  </p:normalViewPr>
  <p:slideViewPr>
    <p:cSldViewPr snapToGrid="0" showGuides="1">
      <p:cViewPr varScale="1">
        <p:scale>
          <a:sx n="63" d="100"/>
          <a:sy n="63" d="100"/>
        </p:scale>
        <p:origin x="1530" y="84"/>
      </p:cViewPr>
      <p:guideLst>
        <p:guide orient="horz" pos="4464"/>
        <p:guide pos="2160"/>
        <p:guide orient="horz" pos="4910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18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commentAuthors" Target="commentAuthors.xml"/><Relationship Id="rId17" Type="http://schemas.microsoft.com/office/2015/10/relationships/revisionInfo" Target="revisionInfo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HNSON, AMBER" userId="a240590e-821d-43fe-8964-1387167fe20e" providerId="ADAL" clId="{4C001A35-64E2-4C02-B088-2500CCE34249}"/>
    <pc:docChg chg="custSel modSld">
      <pc:chgData name="JOHNSON, AMBER" userId="a240590e-821d-43fe-8964-1387167fe20e" providerId="ADAL" clId="{4C001A35-64E2-4C02-B088-2500CCE34249}" dt="2019-03-05T18:11:24.461" v="5" actId="1076"/>
      <pc:docMkLst>
        <pc:docMk/>
      </pc:docMkLst>
      <pc:sldChg chg="addSp delSp modSp">
        <pc:chgData name="JOHNSON, AMBER" userId="a240590e-821d-43fe-8964-1387167fe20e" providerId="ADAL" clId="{4C001A35-64E2-4C02-B088-2500CCE34249}" dt="2019-03-05T18:11:24.461" v="5" actId="1076"/>
        <pc:sldMkLst>
          <pc:docMk/>
          <pc:sldMk cId="3308387879" sldId="279"/>
        </pc:sldMkLst>
        <pc:picChg chg="add del mod">
          <ac:chgData name="JOHNSON, AMBER" userId="a240590e-821d-43fe-8964-1387167fe20e" providerId="ADAL" clId="{4C001A35-64E2-4C02-B088-2500CCE34249}" dt="2019-03-05T18:11:05.318" v="2" actId="478"/>
          <ac:picMkLst>
            <pc:docMk/>
            <pc:sldMk cId="3308387879" sldId="279"/>
            <ac:picMk id="3" creationId="{1FBE2435-9797-4970-A7B7-D1C766E375A6}"/>
          </ac:picMkLst>
        </pc:picChg>
        <pc:picChg chg="add mod">
          <ac:chgData name="JOHNSON, AMBER" userId="a240590e-821d-43fe-8964-1387167fe20e" providerId="ADAL" clId="{4C001A35-64E2-4C02-B088-2500CCE34249}" dt="2019-03-05T18:11:24.461" v="5" actId="1076"/>
          <ac:picMkLst>
            <pc:docMk/>
            <pc:sldMk cId="3308387879" sldId="279"/>
            <ac:picMk id="5" creationId="{8CEFD10B-D3A5-4746-9614-3A0B463EE28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88259EC-B77A-4A5E-8017-A6763F23839A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685800"/>
            <a:ext cx="26479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8EC350-31A7-42E2-BCC8-691C8765B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4280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2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46" algn="l" defTabSz="9142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294" algn="l" defTabSz="9142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40" algn="l" defTabSz="9142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586" algn="l" defTabSz="9142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732" algn="l" defTabSz="9142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880" algn="l" defTabSz="9142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026" algn="l" defTabSz="9142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172" algn="l" defTabSz="914294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5025" y="685800"/>
            <a:ext cx="26479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1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presentative histogram of flow cytometric analysis of MHCII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f CMT167 cells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SA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r LLC cells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SB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ultured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vitr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viv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gated on singlets that were live and either GFP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or GFP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RNA expression of MHCII genes in CMT167 and LLC cells stimulated with IF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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n vitr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n=3, *p&lt;.05, Unpaired T-test)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D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stern Blot of CIITA, p-STAT1, and total STAT1 protein expression of CMT167 and LLC cells stimulated with IF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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8EC350-31A7-42E2-BCC8-691C8765BDC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55600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5025" y="685800"/>
            <a:ext cx="26479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3: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low cytometry on tumor bearing lungs. Events were gated on singlets that were live, CD45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 MHCII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either CD4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A, 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or CD8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, SD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. The frequency of T cells that were positive for CD69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or CD44</a:t>
            </a:r>
            <a:r>
              <a:rPr lang="en-US" sz="1200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+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B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) were compared between mice injected with CMT167-NT-ctrl and CMT167-shCIITA tumors (n=4, Unpaired T-test).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8EC350-31A7-42E2-BCC8-691C8765BDC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39953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05025" y="685800"/>
            <a:ext cx="26479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l Figure 5: SA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Percent Positive MHCII in LLC-EV-ctrl or LLC-CIITAOE cultured in absence of IF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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ated on singlets that were live (n=3, *p&lt;.05, Unpaired T-Test)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B)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RNA expression of MHCII genes in LLC-EV-ctrl or LLC-CIITAOE cultured in absence of IF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/>
              </a:rPr>
              <a:t>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ated on singlets that were live (n=3, ***p&lt;.001, Unpaired T-Test). </a:t>
            </a:r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)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epresentative histogram of MHCII gated on singlets that were live in LLC EV-ctrl and LLC CIITAOE. 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8EC350-31A7-42E2-BCC8-691C8765BDC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734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8"/>
            <a:ext cx="6606540" cy="215603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253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2906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26243" y="537846"/>
            <a:ext cx="1311593" cy="1144143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1469" y="537846"/>
            <a:ext cx="3805238" cy="1144143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3780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2098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7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4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9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4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3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8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2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7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4885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1470" y="3129286"/>
            <a:ext cx="2558415" cy="8849996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9425" y="3129286"/>
            <a:ext cx="2558415" cy="8849996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589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4" y="2251499"/>
            <a:ext cx="3434160" cy="938318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57146" indent="0">
              <a:buNone/>
              <a:defRPr sz="2000" b="1"/>
            </a:lvl2pPr>
            <a:lvl3pPr marL="914294" indent="0">
              <a:buNone/>
              <a:defRPr sz="1800" b="1"/>
            </a:lvl3pPr>
            <a:lvl4pPr marL="1371440" indent="0">
              <a:buNone/>
              <a:defRPr sz="1600" b="1"/>
            </a:lvl4pPr>
            <a:lvl5pPr marL="1828586" indent="0">
              <a:buNone/>
              <a:defRPr sz="1600" b="1"/>
            </a:lvl5pPr>
            <a:lvl6pPr marL="2285732" indent="0">
              <a:buNone/>
              <a:defRPr sz="1600" b="1"/>
            </a:lvl6pPr>
            <a:lvl7pPr marL="2742880" indent="0">
              <a:buNone/>
              <a:defRPr sz="1600" b="1"/>
            </a:lvl7pPr>
            <a:lvl8pPr marL="3200026" indent="0">
              <a:buNone/>
              <a:defRPr sz="1600" b="1"/>
            </a:lvl8pPr>
            <a:lvl9pPr marL="365717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4" y="3189817"/>
            <a:ext cx="3434160" cy="5795222"/>
          </a:xfrm>
        </p:spPr>
        <p:txBody>
          <a:bodyPr/>
          <a:lstStyle>
            <a:lvl1pPr>
              <a:defRPr sz="25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6" y="2251499"/>
            <a:ext cx="3435508" cy="938318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57146" indent="0">
              <a:buNone/>
              <a:defRPr sz="2000" b="1"/>
            </a:lvl2pPr>
            <a:lvl3pPr marL="914294" indent="0">
              <a:buNone/>
              <a:defRPr sz="1800" b="1"/>
            </a:lvl3pPr>
            <a:lvl4pPr marL="1371440" indent="0">
              <a:buNone/>
              <a:defRPr sz="1600" b="1"/>
            </a:lvl4pPr>
            <a:lvl5pPr marL="1828586" indent="0">
              <a:buNone/>
              <a:defRPr sz="1600" b="1"/>
            </a:lvl5pPr>
            <a:lvl6pPr marL="2285732" indent="0">
              <a:buNone/>
              <a:defRPr sz="1600" b="1"/>
            </a:lvl6pPr>
            <a:lvl7pPr marL="2742880" indent="0">
              <a:buNone/>
              <a:defRPr sz="1600" b="1"/>
            </a:lvl7pPr>
            <a:lvl8pPr marL="3200026" indent="0">
              <a:buNone/>
              <a:defRPr sz="1600" b="1"/>
            </a:lvl8pPr>
            <a:lvl9pPr marL="3657172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6" y="3189817"/>
            <a:ext cx="3435508" cy="5795222"/>
          </a:xfrm>
        </p:spPr>
        <p:txBody>
          <a:bodyPr/>
          <a:lstStyle>
            <a:lvl1pPr>
              <a:defRPr sz="25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050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15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998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4" y="400474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6" y="400481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5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4" y="2104821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146" indent="0">
              <a:buNone/>
              <a:defRPr sz="1200"/>
            </a:lvl2pPr>
            <a:lvl3pPr marL="914294" indent="0">
              <a:buNone/>
              <a:defRPr sz="1000"/>
            </a:lvl3pPr>
            <a:lvl4pPr marL="1371440" indent="0">
              <a:buNone/>
              <a:defRPr sz="900"/>
            </a:lvl4pPr>
            <a:lvl5pPr marL="1828586" indent="0">
              <a:buNone/>
              <a:defRPr sz="900"/>
            </a:lvl5pPr>
            <a:lvl6pPr marL="2285732" indent="0">
              <a:buNone/>
              <a:defRPr sz="900"/>
            </a:lvl6pPr>
            <a:lvl7pPr marL="2742880" indent="0">
              <a:buNone/>
              <a:defRPr sz="900"/>
            </a:lvl7pPr>
            <a:lvl8pPr marL="3200026" indent="0">
              <a:buNone/>
              <a:defRPr sz="900"/>
            </a:lvl8pPr>
            <a:lvl9pPr marL="3657172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480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6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6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146" indent="0">
              <a:buNone/>
              <a:defRPr sz="2800"/>
            </a:lvl2pPr>
            <a:lvl3pPr marL="914294" indent="0">
              <a:buNone/>
              <a:defRPr sz="2500"/>
            </a:lvl3pPr>
            <a:lvl4pPr marL="1371440" indent="0">
              <a:buNone/>
              <a:defRPr sz="2000"/>
            </a:lvl4pPr>
            <a:lvl5pPr marL="1828586" indent="0">
              <a:buNone/>
              <a:defRPr sz="2000"/>
            </a:lvl5pPr>
            <a:lvl6pPr marL="2285732" indent="0">
              <a:buNone/>
              <a:defRPr sz="2000"/>
            </a:lvl6pPr>
            <a:lvl7pPr marL="2742880" indent="0">
              <a:buNone/>
              <a:defRPr sz="2000"/>
            </a:lvl7pPr>
            <a:lvl8pPr marL="3200026" indent="0">
              <a:buNone/>
              <a:defRPr sz="2000"/>
            </a:lvl8pPr>
            <a:lvl9pPr marL="3657172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102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146" indent="0">
              <a:buNone/>
              <a:defRPr sz="1200"/>
            </a:lvl2pPr>
            <a:lvl3pPr marL="914294" indent="0">
              <a:buNone/>
              <a:defRPr sz="1000"/>
            </a:lvl3pPr>
            <a:lvl4pPr marL="1371440" indent="0">
              <a:buNone/>
              <a:defRPr sz="900"/>
            </a:lvl4pPr>
            <a:lvl5pPr marL="1828586" indent="0">
              <a:buNone/>
              <a:defRPr sz="900"/>
            </a:lvl5pPr>
            <a:lvl6pPr marL="2285732" indent="0">
              <a:buNone/>
              <a:defRPr sz="900"/>
            </a:lvl6pPr>
            <a:lvl7pPr marL="2742880" indent="0">
              <a:buNone/>
              <a:defRPr sz="900"/>
            </a:lvl7pPr>
            <a:lvl8pPr marL="3200026" indent="0">
              <a:buNone/>
              <a:defRPr sz="900"/>
            </a:lvl8pPr>
            <a:lvl9pPr marL="3657172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5897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29" tIns="45715" rIns="91429" bIns="45715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8"/>
            <a:ext cx="6995160" cy="6638079"/>
          </a:xfrm>
          <a:prstGeom prst="rect">
            <a:avLst/>
          </a:prstGeom>
        </p:spPr>
        <p:txBody>
          <a:bodyPr vert="horz" lIns="91429" tIns="45715" rIns="91429" bIns="45715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55"/>
            <a:ext cx="1813560" cy="535516"/>
          </a:xfrm>
          <a:prstGeom prst="rect">
            <a:avLst/>
          </a:prstGeom>
        </p:spPr>
        <p:txBody>
          <a:bodyPr vert="horz" lIns="91429" tIns="45715" rIns="91429" bIns="45715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5059EB-4D9E-4444-8806-65ECF138E97D}" type="datetimeFigureOut">
              <a:rPr lang="en-US" smtClean="0"/>
              <a:t>1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55"/>
            <a:ext cx="2461260" cy="535516"/>
          </a:xfrm>
          <a:prstGeom prst="rect">
            <a:avLst/>
          </a:prstGeom>
        </p:spPr>
        <p:txBody>
          <a:bodyPr vert="horz" lIns="91429" tIns="45715" rIns="91429" bIns="45715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55"/>
            <a:ext cx="1813560" cy="535516"/>
          </a:xfrm>
          <a:prstGeom prst="rect">
            <a:avLst/>
          </a:prstGeom>
        </p:spPr>
        <p:txBody>
          <a:bodyPr vert="horz" lIns="91429" tIns="45715" rIns="91429" bIns="45715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B70EE-8E65-461C-819A-80D98B5D4F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66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94" rtl="0" eaLnBrk="1" latinLnBrk="0" hangingPunct="1">
        <a:spcBef>
          <a:spcPct val="0"/>
        </a:spcBef>
        <a:buNone/>
        <a:defRPr sz="4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59" indent="-342859" algn="l" defTabSz="914294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63" indent="-285717" algn="l" defTabSz="914294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66" indent="-228574" algn="l" defTabSz="91429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12" indent="-228574" algn="l" defTabSz="914294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60" indent="-228574" algn="l" defTabSz="914294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06" indent="-228574" algn="l" defTabSz="914294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52" indent="-228574" algn="l" defTabSz="914294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00" indent="-228574" algn="l" defTabSz="914294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46" indent="-228574" algn="l" defTabSz="914294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6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94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40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86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32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80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26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72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jp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jp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13" Type="http://schemas.openxmlformats.org/officeDocument/2006/relationships/image" Target="../media/image26.png"/><Relationship Id="rId18" Type="http://schemas.openxmlformats.org/officeDocument/2006/relationships/image" Target="../media/image31.emf"/><Relationship Id="rId26" Type="http://schemas.openxmlformats.org/officeDocument/2006/relationships/image" Target="../media/image39.jpeg"/><Relationship Id="rId3" Type="http://schemas.openxmlformats.org/officeDocument/2006/relationships/image" Target="../media/image16.jpeg"/><Relationship Id="rId21" Type="http://schemas.openxmlformats.org/officeDocument/2006/relationships/image" Target="../media/image34.emf"/><Relationship Id="rId7" Type="http://schemas.openxmlformats.org/officeDocument/2006/relationships/image" Target="../media/image20.jpeg"/><Relationship Id="rId12" Type="http://schemas.openxmlformats.org/officeDocument/2006/relationships/image" Target="../media/image25.png"/><Relationship Id="rId17" Type="http://schemas.openxmlformats.org/officeDocument/2006/relationships/image" Target="../media/image30.jpeg"/><Relationship Id="rId25" Type="http://schemas.openxmlformats.org/officeDocument/2006/relationships/image" Target="../media/image38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9.jpeg"/><Relationship Id="rId20" Type="http://schemas.openxmlformats.org/officeDocument/2006/relationships/image" Target="../media/image3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jpeg"/><Relationship Id="rId11" Type="http://schemas.openxmlformats.org/officeDocument/2006/relationships/image" Target="../media/image24.jpeg"/><Relationship Id="rId24" Type="http://schemas.openxmlformats.org/officeDocument/2006/relationships/image" Target="../media/image37.emf"/><Relationship Id="rId5" Type="http://schemas.openxmlformats.org/officeDocument/2006/relationships/image" Target="../media/image18.jpeg"/><Relationship Id="rId15" Type="http://schemas.openxmlformats.org/officeDocument/2006/relationships/image" Target="../media/image28.png"/><Relationship Id="rId23" Type="http://schemas.openxmlformats.org/officeDocument/2006/relationships/image" Target="../media/image36.emf"/><Relationship Id="rId10" Type="http://schemas.openxmlformats.org/officeDocument/2006/relationships/image" Target="../media/image23.jpeg"/><Relationship Id="rId19" Type="http://schemas.openxmlformats.org/officeDocument/2006/relationships/image" Target="../media/image32.emf"/><Relationship Id="rId4" Type="http://schemas.openxmlformats.org/officeDocument/2006/relationships/image" Target="../media/image17.jpeg"/><Relationship Id="rId9" Type="http://schemas.openxmlformats.org/officeDocument/2006/relationships/image" Target="../media/image22.jpeg"/><Relationship Id="rId14" Type="http://schemas.openxmlformats.org/officeDocument/2006/relationships/image" Target="../media/image27.png"/><Relationship Id="rId22" Type="http://schemas.openxmlformats.org/officeDocument/2006/relationships/image" Target="../media/image35.emf"/><Relationship Id="rId27" Type="http://schemas.openxmlformats.org/officeDocument/2006/relationships/image" Target="../media/image40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3" Type="http://schemas.openxmlformats.org/officeDocument/2006/relationships/image" Target="../media/image41.jpg"/><Relationship Id="rId7" Type="http://schemas.openxmlformats.org/officeDocument/2006/relationships/image" Target="../media/image4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jpg"/><Relationship Id="rId9" Type="http://schemas.openxmlformats.org/officeDocument/2006/relationships/image" Target="../media/image4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52" y="6045314"/>
            <a:ext cx="2487168" cy="2234306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925634"/>
            <a:ext cx="3657600" cy="2042160"/>
          </a:xfrm>
          <a:prstGeom prst="rect">
            <a:avLst/>
          </a:prstGeom>
        </p:spPr>
      </p:pic>
      <p:pic>
        <p:nvPicPr>
          <p:cNvPr id="1120" name="Picture 111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0136" y="3925634"/>
            <a:ext cx="3657600" cy="2078736"/>
          </a:xfrm>
          <a:prstGeom prst="rect">
            <a:avLst/>
          </a:prstGeom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77957" y="2118319"/>
            <a:ext cx="2283498" cy="1548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9" name="Group 8"/>
          <p:cNvGrpSpPr/>
          <p:nvPr/>
        </p:nvGrpSpPr>
        <p:grpSpPr>
          <a:xfrm>
            <a:off x="109920" y="122531"/>
            <a:ext cx="1934181" cy="1877293"/>
            <a:chOff x="51262" y="50307"/>
            <a:chExt cx="3024463" cy="3019425"/>
          </a:xfrm>
        </p:grpSpPr>
        <p:grpSp>
          <p:nvGrpSpPr>
            <p:cNvPr id="8" name="Group 7"/>
            <p:cNvGrpSpPr/>
            <p:nvPr/>
          </p:nvGrpSpPr>
          <p:grpSpPr>
            <a:xfrm>
              <a:off x="51262" y="50307"/>
              <a:ext cx="3024463" cy="3019425"/>
              <a:chOff x="5814720" y="171817"/>
              <a:chExt cx="3024463" cy="3019425"/>
            </a:xfrm>
          </p:grpSpPr>
          <p:pic>
            <p:nvPicPr>
              <p:cNvPr id="1453" name="Picture 429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38344"/>
              <a:stretch/>
            </p:blipFill>
            <p:spPr bwMode="auto">
              <a:xfrm>
                <a:off x="5814720" y="171817"/>
                <a:ext cx="3024463" cy="30194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9" name="Rectangle 48"/>
              <p:cNvSpPr/>
              <p:nvPr/>
            </p:nvSpPr>
            <p:spPr>
              <a:xfrm>
                <a:off x="8727812" y="415751"/>
                <a:ext cx="111371" cy="105262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1115" name="Picture 91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339" t="7378" r="3379" b="59817"/>
            <a:stretch/>
          </p:blipFill>
          <p:spPr bwMode="auto">
            <a:xfrm>
              <a:off x="1234114" y="352491"/>
              <a:ext cx="1600199" cy="8667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50" name="Straight Arrow Connector 49"/>
            <p:cNvCxnSpPr/>
            <p:nvPr/>
          </p:nvCxnSpPr>
          <p:spPr>
            <a:xfrm>
              <a:off x="611238" y="2840440"/>
              <a:ext cx="233337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Group 2"/>
          <p:cNvGrpSpPr/>
          <p:nvPr/>
        </p:nvGrpSpPr>
        <p:grpSpPr>
          <a:xfrm>
            <a:off x="2265529" y="122531"/>
            <a:ext cx="1934181" cy="1877293"/>
            <a:chOff x="3678866" y="6296122"/>
            <a:chExt cx="2679039" cy="2718690"/>
          </a:xfrm>
        </p:grpSpPr>
        <p:grpSp>
          <p:nvGrpSpPr>
            <p:cNvPr id="11" name="Group 10"/>
            <p:cNvGrpSpPr/>
            <p:nvPr/>
          </p:nvGrpSpPr>
          <p:grpSpPr>
            <a:xfrm>
              <a:off x="3678866" y="6296122"/>
              <a:ext cx="2679039" cy="2718690"/>
              <a:chOff x="125693" y="3255155"/>
              <a:chExt cx="3044209" cy="3019425"/>
            </a:xfrm>
          </p:grpSpPr>
          <p:grpSp>
            <p:nvGrpSpPr>
              <p:cNvPr id="10" name="Group 9"/>
              <p:cNvGrpSpPr/>
              <p:nvPr/>
            </p:nvGrpSpPr>
            <p:grpSpPr>
              <a:xfrm>
                <a:off x="125693" y="3255155"/>
                <a:ext cx="3044209" cy="3019425"/>
                <a:chOff x="3283926" y="3257550"/>
                <a:chExt cx="3044209" cy="3019425"/>
              </a:xfrm>
            </p:grpSpPr>
            <p:pic>
              <p:nvPicPr>
                <p:cNvPr id="1458" name="Picture 434"/>
                <p:cNvPicPr>
                  <a:picLocks noChangeAspect="1" noChangeArrowheads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38441"/>
                <a:stretch/>
              </p:blipFill>
              <p:spPr bwMode="auto">
                <a:xfrm>
                  <a:off x="3283926" y="3257550"/>
                  <a:ext cx="2978651" cy="30194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51" name="Rectangle 50"/>
                <p:cNvSpPr/>
                <p:nvPr/>
              </p:nvSpPr>
              <p:spPr>
                <a:xfrm>
                  <a:off x="6197018" y="3506405"/>
                  <a:ext cx="131117" cy="1052623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pic>
            <p:nvPicPr>
              <p:cNvPr id="1134" name="Picture 110"/>
              <p:cNvPicPr>
                <a:picLocks noChangeAspect="1" noChangeArrowheads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648" t="6608" r="2685" b="59492"/>
              <a:stretch/>
            </p:blipFill>
            <p:spPr bwMode="auto">
              <a:xfrm>
                <a:off x="1417379" y="3562067"/>
                <a:ext cx="1552432" cy="8956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cxnSp>
          <p:nvCxnSpPr>
            <p:cNvPr id="53" name="Straight Arrow Connector 52"/>
            <p:cNvCxnSpPr/>
            <p:nvPr/>
          </p:nvCxnSpPr>
          <p:spPr>
            <a:xfrm flipV="1">
              <a:off x="4190721" y="8773474"/>
              <a:ext cx="2138828" cy="159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TextBox 15"/>
          <p:cNvSpPr txBox="1"/>
          <p:nvPr/>
        </p:nvSpPr>
        <p:spPr>
          <a:xfrm>
            <a:off x="0" y="3925634"/>
            <a:ext cx="293630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0" y="1988213"/>
            <a:ext cx="324052" cy="311197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0" y="0"/>
            <a:ext cx="324070" cy="311205"/>
          </a:xfrm>
          <a:prstGeom prst="rect">
            <a:avLst/>
          </a:prstGeom>
          <a:noFill/>
        </p:spPr>
        <p:txBody>
          <a:bodyPr wrap="none" lIns="91429" tIns="45715" rIns="91429" bIns="45715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159876" y="0"/>
            <a:ext cx="324070" cy="311205"/>
          </a:xfrm>
          <a:prstGeom prst="rect">
            <a:avLst/>
          </a:prstGeom>
          <a:noFill/>
        </p:spPr>
        <p:txBody>
          <a:bodyPr wrap="none" lIns="91429" tIns="45715" rIns="91429" bIns="45715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5" name="Group 24"/>
          <p:cNvGrpSpPr/>
          <p:nvPr/>
        </p:nvGrpSpPr>
        <p:grpSpPr>
          <a:xfrm>
            <a:off x="2517458" y="6112545"/>
            <a:ext cx="2150583" cy="2071871"/>
            <a:chOff x="7010400" y="2782146"/>
            <a:chExt cx="2816258" cy="2795400"/>
          </a:xfrm>
        </p:grpSpPr>
        <p:pic>
          <p:nvPicPr>
            <p:cNvPr id="26" name="Picture 4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4699"/>
            <a:stretch/>
          </p:blipFill>
          <p:spPr bwMode="auto">
            <a:xfrm>
              <a:off x="7010400" y="2782146"/>
              <a:ext cx="2810102" cy="2795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7" name="Picture 2"/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25" t="6807" r="3578" b="67485"/>
            <a:stretch/>
          </p:blipFill>
          <p:spPr bwMode="auto">
            <a:xfrm>
              <a:off x="8305800" y="3037569"/>
              <a:ext cx="1352890" cy="6724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Rectangle 27"/>
            <p:cNvSpPr/>
            <p:nvPr/>
          </p:nvSpPr>
          <p:spPr>
            <a:xfrm>
              <a:off x="9759581" y="3037569"/>
              <a:ext cx="67077" cy="59731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29" name="Straight Arrow Connector 28"/>
            <p:cNvCxnSpPr/>
            <p:nvPr/>
          </p:nvCxnSpPr>
          <p:spPr>
            <a:xfrm>
              <a:off x="7543800" y="5356315"/>
              <a:ext cx="2013681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oup 29"/>
          <p:cNvGrpSpPr/>
          <p:nvPr/>
        </p:nvGrpSpPr>
        <p:grpSpPr>
          <a:xfrm>
            <a:off x="4997110" y="6100890"/>
            <a:ext cx="2127852" cy="2084392"/>
            <a:chOff x="7315200" y="5498299"/>
            <a:chExt cx="2578748" cy="2602627"/>
          </a:xfrm>
        </p:grpSpPr>
        <p:pic>
          <p:nvPicPr>
            <p:cNvPr id="31" name="Picture 6"/>
            <p:cNvPicPr>
              <a:picLocks noChangeAspect="1" noChangeArrowheads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6160"/>
            <a:stretch/>
          </p:blipFill>
          <p:spPr bwMode="auto">
            <a:xfrm>
              <a:off x="7315200" y="5498299"/>
              <a:ext cx="2578748" cy="26026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" name="Picture 3"/>
            <p:cNvPicPr>
              <a:picLocks noChangeAspect="1" noChangeArrowheads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820" t="5989" r="2633" b="67827"/>
            <a:stretch/>
          </p:blipFill>
          <p:spPr bwMode="auto">
            <a:xfrm>
              <a:off x="8305800" y="5742683"/>
              <a:ext cx="1435873" cy="681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3" name="Rectangle 32"/>
            <p:cNvSpPr/>
            <p:nvPr/>
          </p:nvSpPr>
          <p:spPr>
            <a:xfrm>
              <a:off x="9827856" y="5733741"/>
              <a:ext cx="66092" cy="5885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4" name="Straight Arrow Connector 33"/>
            <p:cNvCxnSpPr/>
            <p:nvPr/>
          </p:nvCxnSpPr>
          <p:spPr>
            <a:xfrm>
              <a:off x="7814175" y="7914167"/>
              <a:ext cx="2013681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34"/>
          <p:cNvSpPr txBox="1"/>
          <p:nvPr/>
        </p:nvSpPr>
        <p:spPr>
          <a:xfrm>
            <a:off x="4343989" y="0"/>
            <a:ext cx="324052" cy="311197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159876" y="1988213"/>
            <a:ext cx="304851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855151" y="3940757"/>
            <a:ext cx="324087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753836" y="5963800"/>
            <a:ext cx="284012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-33870" y="6009089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528292" y="5982558"/>
            <a:ext cx="23431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1" name="Picture 6"/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58" y="8151153"/>
            <a:ext cx="1914267" cy="18181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5386812" y="9719846"/>
            <a:ext cx="238558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sz="16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9143" y="125304"/>
            <a:ext cx="3200400" cy="18745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8029" y="1999437"/>
            <a:ext cx="3657600" cy="1962061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-18642" y="8098691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3745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08B5B1AE-0C36-014E-894D-772A2CE5AC31}"/>
              </a:ext>
            </a:extLst>
          </p:cNvPr>
          <p:cNvSpPr/>
          <p:nvPr/>
        </p:nvSpPr>
        <p:spPr>
          <a:xfrm>
            <a:off x="213832" y="592200"/>
            <a:ext cx="7183981" cy="2462202"/>
          </a:xfrm>
          <a:prstGeom prst="rect">
            <a:avLst/>
          </a:prstGeom>
        </p:spPr>
        <p:txBody>
          <a:bodyPr wrap="square" lIns="91429" tIns="45715" rIns="91429" bIns="45715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ve histogram of flow cytometric analysis of MHCII+ of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A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MT167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B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LC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ultured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, gated on singlets that were live and eithe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FP-(negative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r GFP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+(positive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C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RNA expression of MHCII genes in CMT167 and LLC cells stimulated with IF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n=3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.05*, Unpaired T-test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D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estern Blot of CIITA, p-STAT1, and total STAT1 protein expression of CMT167 and LLC cells stimulated with IF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E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ld change of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RNA expression of MHCII genes in CMT167-NT-ctrl or CMT167-shCIITA(48, 49, 50) stimulated with IF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relative to CMT-NT-ctrl treated with IF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n=3,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.05*, One-way ANOVA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F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RNA expression of MHCII genes in CMT167-NT-ctrl or CMT167-shCIITA(48) clones stimulated with IF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=4, p&lt;.05*, p&lt;.0001****,One-way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OVA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G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RNA expression of MHCI genes in CMT167-NT-ctrl or CMT167-shCIITA(48) clones stimulated with IF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n=3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p&lt;.05*, One-way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OVA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H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RNA expression of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d274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PD-L1) 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MT167-NT-ctrl or CMT167-shCIITA(48) clones stimulated with IF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tr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=4)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SI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istogram of flow cytometric analysis of MHCII gated on % live of singlets that wer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FP-(negative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J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ve histogram of flow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i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alysis of MHCII gated on % live of singlets that were GFP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+(positive)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K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low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cytometri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alysis of %MHCI+ gated on singlets that are live and GFP-(negative)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n=3, Unpaired T-test). </a:t>
            </a:r>
          </a:p>
        </p:txBody>
      </p:sp>
    </p:spTree>
    <p:extLst>
      <p:ext uri="{BB962C8B-B14F-4D97-AF65-F5344CB8AC3E}">
        <p14:creationId xmlns:p14="http://schemas.microsoft.com/office/powerpoint/2010/main" val="30753728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53" y="5477980"/>
            <a:ext cx="1600200" cy="1669542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755" y="5508206"/>
            <a:ext cx="1600200" cy="1639316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0057" y="5513540"/>
            <a:ext cx="1600200" cy="1633982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5338" y="5520587"/>
            <a:ext cx="1600200" cy="1633982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2176" y="5476137"/>
            <a:ext cx="1600200" cy="1678432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0055" y="3767906"/>
            <a:ext cx="1600200" cy="1664208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53" y="3767906"/>
            <a:ext cx="1600200" cy="1712214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754" y="3767906"/>
            <a:ext cx="1600200" cy="166154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9356" y="3767906"/>
            <a:ext cx="1600200" cy="1633982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457" y="3696350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13897" y="3698758"/>
            <a:ext cx="304851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3012719" y="3679016"/>
            <a:ext cx="293630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500320" y="3667570"/>
            <a:ext cx="324087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4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76"/>
          <a:stretch/>
        </p:blipFill>
        <p:spPr bwMode="auto">
          <a:xfrm>
            <a:off x="3301370" y="8538203"/>
            <a:ext cx="1600200" cy="12374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3"/>
          <p:cNvPicPr>
            <a:picLocks noChangeAspect="1" noChangeArrowheads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450"/>
          <a:stretch/>
        </p:blipFill>
        <p:spPr bwMode="auto">
          <a:xfrm>
            <a:off x="4934863" y="7174371"/>
            <a:ext cx="1600200" cy="1331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03"/>
          <a:stretch/>
        </p:blipFill>
        <p:spPr bwMode="auto">
          <a:xfrm>
            <a:off x="3301370" y="7262698"/>
            <a:ext cx="1600200" cy="1243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5"/>
          <p:cNvPicPr>
            <a:picLocks noChangeAspect="1" noChangeArrowheads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76"/>
          <a:stretch/>
        </p:blipFill>
        <p:spPr bwMode="auto">
          <a:xfrm>
            <a:off x="4962124" y="8538202"/>
            <a:ext cx="1600200" cy="12374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Rectangle 1"/>
          <p:cNvSpPr/>
          <p:nvPr/>
        </p:nvSpPr>
        <p:spPr>
          <a:xfrm>
            <a:off x="-56346" y="9664009"/>
            <a:ext cx="2385589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endParaRPr lang="en-US" sz="1600" dirty="0"/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983" y="188608"/>
            <a:ext cx="1600200" cy="1624203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983" y="2043367"/>
            <a:ext cx="1600200" cy="1624203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1827327" y="5774949"/>
            <a:ext cx="293630" cy="307756"/>
          </a:xfrm>
          <a:prstGeom prst="rect">
            <a:avLst/>
          </a:prstGeom>
          <a:noFill/>
        </p:spPr>
        <p:txBody>
          <a:bodyPr wrap="squar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7014" y="7823331"/>
            <a:ext cx="284012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827327" y="7823331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7014" y="22814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12522" y="1856177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Picture 41"/>
          <p:cNvPicPr>
            <a:picLocks/>
          </p:cNvPicPr>
          <p:nvPr/>
        </p:nvPicPr>
        <p:blipFill rotWithShape="1">
          <a:blip r:embed="rId18"/>
          <a:srcRect t="8339" b="13580"/>
          <a:stretch/>
        </p:blipFill>
        <p:spPr>
          <a:xfrm>
            <a:off x="1693869" y="295876"/>
            <a:ext cx="13716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/>
          <p:cNvPicPr>
            <a:picLocks/>
          </p:cNvPicPr>
          <p:nvPr/>
        </p:nvPicPr>
        <p:blipFill rotWithShape="1">
          <a:blip r:embed="rId19"/>
          <a:srcRect t="8650" b="14457"/>
          <a:stretch/>
        </p:blipFill>
        <p:spPr>
          <a:xfrm>
            <a:off x="3205897" y="295876"/>
            <a:ext cx="13716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/>
          <p:cNvPicPr>
            <a:picLocks/>
          </p:cNvPicPr>
          <p:nvPr/>
        </p:nvPicPr>
        <p:blipFill rotWithShape="1">
          <a:blip r:embed="rId20"/>
          <a:srcRect t="-148" b="15288"/>
          <a:stretch/>
        </p:blipFill>
        <p:spPr>
          <a:xfrm>
            <a:off x="4717925" y="295876"/>
            <a:ext cx="13716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/>
          <p:cNvPicPr>
            <a:picLocks/>
          </p:cNvPicPr>
          <p:nvPr/>
        </p:nvPicPr>
        <p:blipFill>
          <a:blip r:embed="rId21"/>
          <a:stretch>
            <a:fillRect/>
          </a:stretch>
        </p:blipFill>
        <p:spPr>
          <a:xfrm>
            <a:off x="1693869" y="1979237"/>
            <a:ext cx="13716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/>
          <p:cNvPicPr>
            <a:picLocks/>
          </p:cNvPicPr>
          <p:nvPr/>
        </p:nvPicPr>
        <p:blipFill>
          <a:blip r:embed="rId22"/>
          <a:stretch>
            <a:fillRect/>
          </a:stretch>
        </p:blipFill>
        <p:spPr>
          <a:xfrm>
            <a:off x="3205897" y="1964889"/>
            <a:ext cx="13716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Picture 47"/>
          <p:cNvPicPr>
            <a:picLocks/>
          </p:cNvPicPr>
          <p:nvPr/>
        </p:nvPicPr>
        <p:blipFill rotWithShape="1">
          <a:blip r:embed="rId23"/>
          <a:srcRect t="-486" b="18613"/>
          <a:stretch/>
        </p:blipFill>
        <p:spPr>
          <a:xfrm>
            <a:off x="4717925" y="1964889"/>
            <a:ext cx="13716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0" name="Straight Arrow Connector 49"/>
          <p:cNvCxnSpPr>
            <a:stCxn id="42" idx="3"/>
            <a:endCxn id="43" idx="1"/>
          </p:cNvCxnSpPr>
          <p:nvPr/>
        </p:nvCxnSpPr>
        <p:spPr>
          <a:xfrm>
            <a:off x="3065469" y="981676"/>
            <a:ext cx="14042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stCxn id="43" idx="3"/>
            <a:endCxn id="44" idx="1"/>
          </p:cNvCxnSpPr>
          <p:nvPr/>
        </p:nvCxnSpPr>
        <p:spPr>
          <a:xfrm>
            <a:off x="4577497" y="981676"/>
            <a:ext cx="14042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stCxn id="46" idx="3"/>
            <a:endCxn id="47" idx="1"/>
          </p:cNvCxnSpPr>
          <p:nvPr/>
        </p:nvCxnSpPr>
        <p:spPr>
          <a:xfrm flipV="1">
            <a:off x="3065469" y="2650689"/>
            <a:ext cx="140428" cy="1434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>
            <a:stCxn id="47" idx="3"/>
            <a:endCxn id="48" idx="1"/>
          </p:cNvCxnSpPr>
          <p:nvPr/>
        </p:nvCxnSpPr>
        <p:spPr>
          <a:xfrm>
            <a:off x="4577497" y="2650689"/>
            <a:ext cx="140428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Elbow Connector 57"/>
          <p:cNvCxnSpPr>
            <a:stCxn id="44" idx="2"/>
            <a:endCxn id="46" idx="0"/>
          </p:cNvCxnSpPr>
          <p:nvPr/>
        </p:nvCxnSpPr>
        <p:spPr>
          <a:xfrm rot="5400000">
            <a:off x="3735817" y="311328"/>
            <a:ext cx="311761" cy="3024056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Arrow Connector 60"/>
          <p:cNvCxnSpPr>
            <a:stCxn id="48" idx="3"/>
          </p:cNvCxnSpPr>
          <p:nvPr/>
        </p:nvCxnSpPr>
        <p:spPr>
          <a:xfrm>
            <a:off x="6089525" y="2650689"/>
            <a:ext cx="140428" cy="717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1512858" y="17282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Picture 64"/>
          <p:cNvPicPr>
            <a:picLocks/>
          </p:cNvPicPr>
          <p:nvPr/>
        </p:nvPicPr>
        <p:blipFill>
          <a:blip r:embed="rId24"/>
          <a:stretch>
            <a:fillRect/>
          </a:stretch>
        </p:blipFill>
        <p:spPr>
          <a:xfrm>
            <a:off x="6255144" y="1972063"/>
            <a:ext cx="1371600" cy="137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Picture 67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53" y="7172914"/>
            <a:ext cx="1600200" cy="1633982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755" y="7160218"/>
            <a:ext cx="1600200" cy="163398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8659" y="3767906"/>
            <a:ext cx="1600200" cy="1633982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6018378" y="3667570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-3443" y="5404946"/>
            <a:ext cx="23431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504997" y="5407354"/>
            <a:ext cx="284012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3003819" y="5387612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4491420" y="5376166"/>
            <a:ext cx="293630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6009478" y="5376166"/>
            <a:ext cx="333705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-28793" y="7004610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479647" y="7007018"/>
            <a:ext cx="324087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3007013" y="7007018"/>
            <a:ext cx="304851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696FD024-A0AA-8B4B-9E4C-6B79FB53347D}"/>
              </a:ext>
            </a:extLst>
          </p:cNvPr>
          <p:cNvSpPr/>
          <p:nvPr/>
        </p:nvSpPr>
        <p:spPr>
          <a:xfrm>
            <a:off x="8461248" y="4651564"/>
            <a:ext cx="7772401" cy="1785094"/>
          </a:xfrm>
          <a:prstGeom prst="rect">
            <a:avLst/>
          </a:prstGeom>
        </p:spPr>
        <p:txBody>
          <a:bodyPr wrap="square" lIns="91429" tIns="45715" rIns="91429" bIns="45715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RT-pcr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on GFP+ cells FACs sorted from CMT167-NT-ctrl and CMT167-shCIITA for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A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cxcl9, 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B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cxcl10. SC) Gating strategy for T cell flow cytometry, events were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ned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on singlets that were live that were CD45+ and MHCII- and either CD4+ or CD8+. Flow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ytometry on tumor bearing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ungs of th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requency of T cell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mpar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etween mice injected with CMT167-NT-ctrl and CMT167-shCIITA tumors (n=4, Unpaired T-tes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of CD4 T cells that were D) IL4+, E) IL17+, F) FoxP3+, G)CD69+, H) CD44+ or CD8 T cells I)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NFa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+, J) CD69+, and K) CD44+ . Flow Cytometry analysis of exhaustion markers on CD4 T cells L) PD1 and M) CTLA4 and CD8 T cells N) CTLA4, and O) PD1. Flow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ytometry Plot for CD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gated on singlets that are live and CD45+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P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or CD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cultur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lone, CD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stimulated with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MA/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onomyc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co-cultured with CMT-NT-ctrl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ells, an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co-cultured with CMT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hCIIT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24876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696FD024-A0AA-8B4B-9E4C-6B79FB53347D}"/>
              </a:ext>
            </a:extLst>
          </p:cNvPr>
          <p:cNvSpPr/>
          <p:nvPr/>
        </p:nvSpPr>
        <p:spPr>
          <a:xfrm>
            <a:off x="96253" y="488317"/>
            <a:ext cx="7567863" cy="1785094"/>
          </a:xfrm>
          <a:prstGeom prst="rect">
            <a:avLst/>
          </a:prstGeom>
        </p:spPr>
        <p:txBody>
          <a:bodyPr wrap="square" lIns="91429" tIns="45715" rIns="91429" bIns="45715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PCR on GFP+ cells FACs sorted from CMT167-NT-ctrl and CMT167-shCIITA for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A)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xcl9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B) </a:t>
            </a:r>
            <a:r>
              <a:rPr lang="en-US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xcl10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C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ating strategy for T cell flow cytometry, events were gated on singlets that were live that were CD45+ and MHCII- and either CD4+ or CD8+. Flow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ytometry on tumor bearing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ungs of th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requency of T cell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mpar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etween mice injected with CMT167-NT-ctrl and CMT167-shCIITA tumors (n=4, Unpaired T-tes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of CD4 T cells that we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D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L4+,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E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L17+,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F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oxP3+,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G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69+,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H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44+ or CD8+ T cells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I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NF</a:t>
            </a:r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+,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J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69+, 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K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44+ . Flow Cytometry analysis of exhaustion markers on CD4+ T cells for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L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TLA4+ 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M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D-1+ and CD8+ T cells for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N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TLA4+, and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O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D-1+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P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low Cytometry Plot for CD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gated on singlets that ar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ive and CD45+ for IF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for CD4</a:t>
            </a:r>
            <a:r>
              <a:rPr lang="en-US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ells culture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lone, CD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stimulated with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MA/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onomyci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co-cultured with CMT-NT-ctrl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ells, an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T cells co-cultured with CMT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hCIIT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48591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198" y="6286300"/>
            <a:ext cx="2869456" cy="2286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113" y="6259251"/>
            <a:ext cx="2743200" cy="2292096"/>
          </a:xfrm>
          <a:prstGeom prst="rect">
            <a:avLst/>
          </a:prstGeom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13883" y="309560"/>
            <a:ext cx="3217486" cy="2303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3" name="Picture 3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011"/>
          <a:stretch/>
        </p:blipFill>
        <p:spPr bwMode="auto">
          <a:xfrm>
            <a:off x="76217" y="3"/>
            <a:ext cx="2808874" cy="27600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19734" y="0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7" name="Picture 6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071" t="5869" r="1789" b="65375"/>
          <a:stretch/>
        </p:blipFill>
        <p:spPr bwMode="auto">
          <a:xfrm>
            <a:off x="1871426" y="296189"/>
            <a:ext cx="829259" cy="6542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8" name="Straight Arrow Connector 17"/>
          <p:cNvCxnSpPr/>
          <p:nvPr/>
        </p:nvCxnSpPr>
        <p:spPr>
          <a:xfrm>
            <a:off x="651489" y="2548024"/>
            <a:ext cx="2217835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ctangle 18"/>
          <p:cNvSpPr/>
          <p:nvPr/>
        </p:nvSpPr>
        <p:spPr>
          <a:xfrm>
            <a:off x="6746011" y="295092"/>
            <a:ext cx="65652" cy="7890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29" tIns="45715" rIns="91429" bIns="45715"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3163373" y="0"/>
            <a:ext cx="314469" cy="307756"/>
          </a:xfrm>
          <a:prstGeom prst="rect">
            <a:avLst/>
          </a:prstGeom>
          <a:noFill/>
        </p:spPr>
        <p:txBody>
          <a:bodyPr wrap="none" lIns="91420" tIns="45710" rIns="91420" bIns="45710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Rectangle 1"/>
          <p:cNvSpPr/>
          <p:nvPr/>
        </p:nvSpPr>
        <p:spPr>
          <a:xfrm>
            <a:off x="2847220" y="177504"/>
            <a:ext cx="172720" cy="76917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29" tIns="45715" rIns="91429" bIns="45715" rtlCol="0" anchor="ctr"/>
          <a:lstStyle/>
          <a:p>
            <a:pPr algn="ctr"/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198" y="3018468"/>
            <a:ext cx="3130555" cy="3038479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491195" y="6135317"/>
            <a:ext cx="293648" cy="307766"/>
          </a:xfrm>
          <a:prstGeom prst="rect">
            <a:avLst/>
          </a:prstGeom>
          <a:noFill/>
        </p:spPr>
        <p:txBody>
          <a:bodyPr wrap="none" lIns="91429" tIns="45715" rIns="91429" bIns="45715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27CBA8F1-0AFC-6944-A5BF-19DE24330BCA}"/>
              </a:ext>
            </a:extLst>
          </p:cNvPr>
          <p:cNvSpPr/>
          <p:nvPr/>
        </p:nvSpPr>
        <p:spPr>
          <a:xfrm>
            <a:off x="152434" y="8772399"/>
            <a:ext cx="7160732" cy="1107986"/>
          </a:xfrm>
          <a:prstGeom prst="rect">
            <a:avLst/>
          </a:prstGeom>
        </p:spPr>
        <p:txBody>
          <a:bodyPr wrap="square" lIns="91429" tIns="45715" rIns="91429" bIns="45715">
            <a:spAutoFit/>
          </a:bodyPr>
          <a:lstStyle/>
          <a:p>
            <a:pPr algn="just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: (SA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ve histogram of MHCII gated on singlets that were live in LLC EV-ctrl and LLC CIITAOE.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SB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RNA expression of MHCII genes in LLC-EV-ctrl or LLC-CIITAOE cultured in absence of IF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 (n=3)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atmap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RNA-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rom CCLE data of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C)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HCI or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SD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HCII associat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enes of KRAS mutant human adenocarcinoma cell lines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asal expression of Human MHCII genes (HLA-DR, HLA-DQ, CD74) in KRAS mutated lung adenocarcinoma human cell lines measured by flow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ytometry (n=3)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F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%HLA-DR positive cells of NSCLC cells treated with IFN</a:t>
            </a:r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for 48 hours (n=3, p&lt;.01**, p&lt;.001***, Unpaired T-test)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491195" y="2944242"/>
            <a:ext cx="314487" cy="307766"/>
          </a:xfrm>
          <a:prstGeom prst="rect">
            <a:avLst/>
          </a:prstGeom>
          <a:noFill/>
        </p:spPr>
        <p:txBody>
          <a:bodyPr wrap="none" lIns="91429" tIns="45715" rIns="91429" bIns="45715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0" y="6182615"/>
            <a:ext cx="304869" cy="307766"/>
          </a:xfrm>
          <a:prstGeom prst="rect">
            <a:avLst/>
          </a:prstGeom>
          <a:noFill/>
        </p:spPr>
        <p:txBody>
          <a:bodyPr wrap="none" lIns="91429" tIns="45715" rIns="91429" bIns="45715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018468"/>
            <a:ext cx="3108966" cy="3017526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0" y="2944242"/>
            <a:ext cx="314487" cy="307766"/>
          </a:xfrm>
          <a:prstGeom prst="rect">
            <a:avLst/>
          </a:prstGeom>
          <a:noFill/>
        </p:spPr>
        <p:txBody>
          <a:bodyPr wrap="none" lIns="91429" tIns="45715" rIns="91429" bIns="45715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299976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4084646"/>
              </p:ext>
            </p:extLst>
          </p:nvPr>
        </p:nvGraphicFramePr>
        <p:xfrm>
          <a:off x="325875" y="4807554"/>
          <a:ext cx="6994525" cy="4279900"/>
        </p:xfrm>
        <a:graphic>
          <a:graphicData uri="http://schemas.openxmlformats.org/drawingml/2006/table">
            <a:tbl>
              <a:tblPr firstRow="1" firstCol="1" bandRow="1"/>
              <a:tblGrid>
                <a:gridCol w="1271697">
                  <a:extLst>
                    <a:ext uri="{9D8B030D-6E8A-4147-A177-3AD203B41FA5}">
                      <a16:colId xmlns:a16="http://schemas.microsoft.com/office/drawing/2014/main" val="4113744409"/>
                    </a:ext>
                  </a:extLst>
                </a:gridCol>
                <a:gridCol w="1633308">
                  <a:extLst>
                    <a:ext uri="{9D8B030D-6E8A-4147-A177-3AD203B41FA5}">
                      <a16:colId xmlns:a16="http://schemas.microsoft.com/office/drawing/2014/main" val="2297409430"/>
                    </a:ext>
                  </a:extLst>
                </a:gridCol>
                <a:gridCol w="3169920">
                  <a:extLst>
                    <a:ext uri="{9D8B030D-6E8A-4147-A177-3AD203B41FA5}">
                      <a16:colId xmlns:a16="http://schemas.microsoft.com/office/drawing/2014/main" val="2441747718"/>
                    </a:ext>
                  </a:extLst>
                </a:gridCol>
                <a:gridCol w="919600">
                  <a:extLst>
                    <a:ext uri="{9D8B030D-6E8A-4147-A177-3AD203B41FA5}">
                      <a16:colId xmlns:a16="http://schemas.microsoft.com/office/drawing/2014/main" val="1463657951"/>
                    </a:ext>
                  </a:extLst>
                </a:gridCol>
              </a:tblGrid>
              <a:tr h="165100">
                <a:tc gridSpan="4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ytek Aurora Spectral Flow Antibodies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52510178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nti-mouse FC Block (CD16/CD32) 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Bioscience</a:t>
                      </a: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14-0161-86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</a:t>
                      </a:r>
                      <a:r>
                        <a:rPr lang="en-US" sz="1000" baseline="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panel 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3228237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3e-PerCP-Cy5.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10032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2635223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4-Pacific Blu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100534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1212977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8-BV57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10073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1765617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11b-BV1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10124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30413283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y6G-APCFire75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12765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9319895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69-BV42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10452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3148137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HCII-BV65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10764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5920156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19-BV71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11555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2922173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DL1-BV78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12433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5789837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45-AF53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Bioscience 58-0451-8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2844622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y6C-Super Bright 43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Bioscience 62-5932-8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979465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64-BV60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13932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3140787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11c-BV48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74639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3691878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HC1-AP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Bioscience 17-5999-8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0547353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D44-BB70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D Biosciences 56650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414395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D1-P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Bioscience 12-9981-8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0659868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CR2-PECy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15061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ell Surface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726185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Zombie NIR Viability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42310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Live/Dead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1199688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OMES-PEef61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Bioscience 61-4875-8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tracellula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1426153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Ki67-FITC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Bioscience</a:t>
                      </a:r>
                      <a:r>
                        <a:rPr lang="en-US" sz="1000" u="none" strike="noStrike" dirty="0">
                          <a:solidFill>
                            <a:srgbClr val="0000FF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00" u="none" strike="noStrike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-5698-80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tracellula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2235002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iglecF-BB515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D Biosciences 56621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tracellula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3964853"/>
                  </a:ext>
                </a:extLst>
              </a:tr>
              <a:tr h="16002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oxP3-AF64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Biolegend 126407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29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YTEK panel </a:t>
                      </a:r>
                      <a:endParaRPr kumimoji="0" lang="en-US" sz="1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Intracellula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57359"/>
                  </a:ext>
                </a:extLst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3151720"/>
              </p:ext>
            </p:extLst>
          </p:nvPr>
        </p:nvGraphicFramePr>
        <p:xfrm>
          <a:off x="325876" y="353504"/>
          <a:ext cx="6994525" cy="4223766"/>
        </p:xfrm>
        <a:graphic>
          <a:graphicData uri="http://schemas.openxmlformats.org/drawingml/2006/table">
            <a:tbl>
              <a:tblPr firstRow="1" firstCol="1" bandRow="1"/>
              <a:tblGrid>
                <a:gridCol w="126861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000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20010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2574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92768">
                <a:tc gridSpan="4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Arial"/>
                          <a:ea typeface="Calibri"/>
                          <a:cs typeface="Times New Roman"/>
                        </a:rPr>
                        <a:t>Flow Cytometry Antibodies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Anti-mouse FcBlock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14-0161-86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; T cell Stimulation; T cell Co-cultur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D44-FITC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11-0441-81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PD-1-P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12-9981-81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A/IE-PE/Dazzle594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56-0451-8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; T cell Stimulation; T cell Co-cultur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D3e-PerCP Cy5.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596900" algn="l"/>
                        </a:tabLs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45-0031-8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D69-PECy7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25-0691-81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; T cell Co-cultur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D45-AF70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56-0451-8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; T cell Stimulation; T cell Stimulation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D8a-APC EF78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47-0081-8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; T cell Stimulation; T cell Stimulation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D4-eF45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48-0042-8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; T cell Stimulation; T cell Stimulation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Aqua Viability dy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hermoFisher L34957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Phenotypic; T cell Stimulation; T cell Stimulation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Live/Dead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FNγ-AF488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53-4301-8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Stimulation; T cell Co-cultur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ntracellular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L4-P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12-7041-41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Stimulation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ntracellular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NFα-PerCP-Cy5.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BD 560537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Stimulation; T cell Co-cultur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ntracellular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L-17a-PECy7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25-4321-8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Stimulation; T cell Co-cultur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ntracellular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FoxP3-eF660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50-5773-8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Stimulation; T cell Co-cultur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ntracellular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L10-P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12-4031-82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T cell Co-cultur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Intracellular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504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Hu-FcR Binding Inhibitor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14-9161-71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Human MHCII panel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 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D74-FITC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eBioscience 11-0748-41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Human MHCII panel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HLA-DQ-PE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Biolegend 318105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Human MHCII panel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75244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HLA-DR-APC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Biolegend 307609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Human MHCII panel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Cell Surfac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350488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Ghost Violet 510 Viability Dye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TONBO biosciences 13-0870-T100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/>
                          <a:ea typeface="Calibri"/>
                          <a:cs typeface="Times New Roman"/>
                        </a:rPr>
                        <a:t>Human MHCII panel</a:t>
                      </a:r>
                      <a:endParaRPr lang="en-US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/>
                          <a:ea typeface="Calibri"/>
                          <a:cs typeface="Times New Roman"/>
                        </a:rPr>
                        <a:t>Live/Dead</a:t>
                      </a:r>
                      <a:endParaRPr lang="en-US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74" marR="6857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192504" y="9207770"/>
            <a:ext cx="6725653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: List of 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Flow Cytometry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ntibodies used in studies.</a:t>
            </a:r>
          </a:p>
        </p:txBody>
      </p:sp>
    </p:spTree>
    <p:extLst>
      <p:ext uri="{BB962C8B-B14F-4D97-AF65-F5344CB8AC3E}">
        <p14:creationId xmlns:p14="http://schemas.microsoft.com/office/powerpoint/2010/main" val="1868714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7CCBAB820DFD445B458281F1545500D" ma:contentTypeVersion="9" ma:contentTypeDescription="Create a new document." ma:contentTypeScope="" ma:versionID="04f60073745238907cc25a9d05125792">
  <xsd:schema xmlns:xsd="http://www.w3.org/2001/XMLSchema" xmlns:xs="http://www.w3.org/2001/XMLSchema" xmlns:p="http://schemas.microsoft.com/office/2006/metadata/properties" xmlns:ns3="e09adbd9-ed18-4704-8644-e03b888018e2" targetNamespace="http://schemas.microsoft.com/office/2006/metadata/properties" ma:root="true" ma:fieldsID="66ecd1ba2e315a642b20b3b5edef2d32" ns3:_="">
    <xsd:import namespace="e09adbd9-ed18-4704-8644-e03b888018e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09adbd9-ed18-4704-8644-e03b888018e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5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6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BF6A309-54E7-4195-A7E3-25D87F3D8B23}">
  <ds:schemaRefs>
    <ds:schemaRef ds:uri="http://purl.org/dc/terms/"/>
    <ds:schemaRef ds:uri="e09adbd9-ed18-4704-8644-e03b888018e2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899F7E6B-546F-4299-A0B3-85E822E7B0A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443345D-6AB0-409C-B8EB-F1E9CAEA3E3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09adbd9-ed18-4704-8644-e03b888018e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0238</TotalTime>
  <Words>1621</Words>
  <Application>Microsoft Office PowerPoint</Application>
  <PresentationFormat>Custom</PresentationFormat>
  <Paragraphs>227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AMBER</dc:creator>
  <cp:lastModifiedBy>JOHNSON, AMBER</cp:lastModifiedBy>
  <cp:revision>479</cp:revision>
  <cp:lastPrinted>2018-11-05T18:05:37Z</cp:lastPrinted>
  <dcterms:created xsi:type="dcterms:W3CDTF">2017-10-26T19:01:02Z</dcterms:created>
  <dcterms:modified xsi:type="dcterms:W3CDTF">2020-01-09T18:47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CCBAB820DFD445B458281F1545500D</vt:lpwstr>
  </property>
</Properties>
</file>